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6" d="100"/>
          <a:sy n="86" d="100"/>
        </p:scale>
        <p:origin x="30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A2CA3-9348-4763-8AA7-67A4424EB822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C26E3-D506-4B1F-BF63-FD9B2849C6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95179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A2CA3-9348-4763-8AA7-67A4424EB822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C26E3-D506-4B1F-BF63-FD9B2849C6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59370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A2CA3-9348-4763-8AA7-67A4424EB822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C26E3-D506-4B1F-BF63-FD9B2849C6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02764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A2CA3-9348-4763-8AA7-67A4424EB822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C26E3-D506-4B1F-BF63-FD9B2849C6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52482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A2CA3-9348-4763-8AA7-67A4424EB822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C26E3-D506-4B1F-BF63-FD9B2849C6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98746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A2CA3-9348-4763-8AA7-67A4424EB822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C26E3-D506-4B1F-BF63-FD9B2849C6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44933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A2CA3-9348-4763-8AA7-67A4424EB822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C26E3-D506-4B1F-BF63-FD9B2849C6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78006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A2CA3-9348-4763-8AA7-67A4424EB822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C26E3-D506-4B1F-BF63-FD9B2849C6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53408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A2CA3-9348-4763-8AA7-67A4424EB822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C26E3-D506-4B1F-BF63-FD9B2849C6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07821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A2CA3-9348-4763-8AA7-67A4424EB822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C26E3-D506-4B1F-BF63-FD9B2849C6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10582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A2CA3-9348-4763-8AA7-67A4424EB822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C26E3-D506-4B1F-BF63-FD9B2849C6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06658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AA2CA3-9348-4763-8AA7-67A4424EB822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7C26E3-D506-4B1F-BF63-FD9B2849C63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9209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组合 8"/>
          <p:cNvGrpSpPr/>
          <p:nvPr/>
        </p:nvGrpSpPr>
        <p:grpSpPr>
          <a:xfrm>
            <a:off x="1248937" y="818553"/>
            <a:ext cx="9508755" cy="1634715"/>
            <a:chOff x="1248937" y="818553"/>
            <a:chExt cx="9508755" cy="1634715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50663" y="818553"/>
              <a:ext cx="8807029" cy="1634715"/>
            </a:xfrm>
            <a:prstGeom prst="rect">
              <a:avLst/>
            </a:prstGeom>
          </p:spPr>
        </p:pic>
        <p:sp>
          <p:nvSpPr>
            <p:cNvPr id="6" name="文本框 5"/>
            <p:cNvSpPr txBox="1"/>
            <p:nvPr/>
          </p:nvSpPr>
          <p:spPr>
            <a:xfrm>
              <a:off x="1248937" y="1471959"/>
              <a:ext cx="3902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" name="组合 9"/>
          <p:cNvGrpSpPr/>
          <p:nvPr/>
        </p:nvGrpSpPr>
        <p:grpSpPr>
          <a:xfrm>
            <a:off x="1256374" y="3172519"/>
            <a:ext cx="8968713" cy="1828800"/>
            <a:chOff x="1256374" y="3172519"/>
            <a:chExt cx="8968713" cy="1828800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66912" y="3172519"/>
              <a:ext cx="8258175" cy="1828800"/>
            </a:xfrm>
            <a:prstGeom prst="rect">
              <a:avLst/>
            </a:prstGeom>
          </p:spPr>
        </p:pic>
        <p:sp>
          <p:nvSpPr>
            <p:cNvPr id="7" name="文本框 6"/>
            <p:cNvSpPr txBox="1"/>
            <p:nvPr/>
          </p:nvSpPr>
          <p:spPr>
            <a:xfrm>
              <a:off x="1256374" y="3899203"/>
              <a:ext cx="3902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8" name="文本框 7"/>
          <p:cNvSpPr txBox="1"/>
          <p:nvPr/>
        </p:nvSpPr>
        <p:spPr>
          <a:xfrm>
            <a:off x="1966913" y="5564459"/>
            <a:ext cx="958575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 Subgroup analysis of sulfonylureas and other oral hypoglycemic drugs as control group</a:t>
            </a:r>
            <a:endParaRPr lang="zh-CN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A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sulfonylureas; B: other oral hypoglycemic drugs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415461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8</Words>
  <Application>Microsoft Office PowerPoint</Application>
  <PresentationFormat>宽屏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>PKUI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ai Sanbao</dc:creator>
  <cp:lastModifiedBy>Chai Sanbao</cp:lastModifiedBy>
  <cp:revision>1</cp:revision>
  <dcterms:created xsi:type="dcterms:W3CDTF">2023-03-10T06:39:35Z</dcterms:created>
  <dcterms:modified xsi:type="dcterms:W3CDTF">2023-03-10T06:42:59Z</dcterms:modified>
</cp:coreProperties>
</file>